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15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D561F-9E1A-41F5-A4F4-73A62FFA55BF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55134-CC2C-4BFF-8D9F-FFA1619BA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7032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D561F-9E1A-41F5-A4F4-73A62FFA55BF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55134-CC2C-4BFF-8D9F-FFA1619BA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2340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D561F-9E1A-41F5-A4F4-73A62FFA55BF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55134-CC2C-4BFF-8D9F-FFA1619BA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0942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D561F-9E1A-41F5-A4F4-73A62FFA55BF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55134-CC2C-4BFF-8D9F-FFA1619BA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82361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D561F-9E1A-41F5-A4F4-73A62FFA55BF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55134-CC2C-4BFF-8D9F-FFA1619BA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2447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D561F-9E1A-41F5-A4F4-73A62FFA55BF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55134-CC2C-4BFF-8D9F-FFA1619BA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7255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D561F-9E1A-41F5-A4F4-73A62FFA55BF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55134-CC2C-4BFF-8D9F-FFA1619BA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0469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D561F-9E1A-41F5-A4F4-73A62FFA55BF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55134-CC2C-4BFF-8D9F-FFA1619BA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0664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D561F-9E1A-41F5-A4F4-73A62FFA55BF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55134-CC2C-4BFF-8D9F-FFA1619BA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53005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D561F-9E1A-41F5-A4F4-73A62FFA55BF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55134-CC2C-4BFF-8D9F-FFA1619BA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3166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D561F-9E1A-41F5-A4F4-73A62FFA55BF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655134-CC2C-4BFF-8D9F-FFA1619BA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7611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3D561F-9E1A-41F5-A4F4-73A62FFA55BF}" type="datetimeFigureOut">
              <a:rPr lang="zh-CN" altLang="en-US" smtClean="0"/>
              <a:t>2020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655134-CC2C-4BFF-8D9F-FFA1619BA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9991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1B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387044"/>
            <a:ext cx="8229600" cy="2952274"/>
          </a:xfrm>
        </p:spPr>
      </p:pic>
    </p:spTree>
    <p:extLst>
      <p:ext uri="{BB962C8B-B14F-4D97-AF65-F5344CB8AC3E}">
        <p14:creationId xmlns:p14="http://schemas.microsoft.com/office/powerpoint/2010/main" val="21531548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6D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2481" y="1600200"/>
            <a:ext cx="6959037" cy="4525963"/>
          </a:xfrm>
        </p:spPr>
      </p:pic>
    </p:spTree>
    <p:extLst>
      <p:ext uri="{BB962C8B-B14F-4D97-AF65-F5344CB8AC3E}">
        <p14:creationId xmlns:p14="http://schemas.microsoft.com/office/powerpoint/2010/main" val="22414475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6E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525" y="1600200"/>
            <a:ext cx="7736950" cy="4525963"/>
          </a:xfrm>
        </p:spPr>
      </p:pic>
    </p:spTree>
    <p:extLst>
      <p:ext uri="{BB962C8B-B14F-4D97-AF65-F5344CB8AC3E}">
        <p14:creationId xmlns:p14="http://schemas.microsoft.com/office/powerpoint/2010/main" val="155008918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6I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6563" y="1196752"/>
            <a:ext cx="4817541" cy="5472608"/>
          </a:xfrm>
        </p:spPr>
      </p:pic>
    </p:spTree>
    <p:extLst>
      <p:ext uri="{BB962C8B-B14F-4D97-AF65-F5344CB8AC3E}">
        <p14:creationId xmlns:p14="http://schemas.microsoft.com/office/powerpoint/2010/main" val="125398960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6J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5776" y="1099401"/>
            <a:ext cx="4104456" cy="5626267"/>
          </a:xfrm>
        </p:spPr>
      </p:pic>
    </p:spTree>
    <p:extLst>
      <p:ext uri="{BB962C8B-B14F-4D97-AF65-F5344CB8AC3E}">
        <p14:creationId xmlns:p14="http://schemas.microsoft.com/office/powerpoint/2010/main" val="30539540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4B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364242"/>
            <a:ext cx="8229600" cy="2997879"/>
          </a:xfrm>
        </p:spPr>
      </p:pic>
    </p:spTree>
    <p:extLst>
      <p:ext uri="{BB962C8B-B14F-4D97-AF65-F5344CB8AC3E}">
        <p14:creationId xmlns:p14="http://schemas.microsoft.com/office/powerpoint/2010/main" val="1811554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4D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283" y="1600200"/>
            <a:ext cx="7993434" cy="4525963"/>
          </a:xfrm>
        </p:spPr>
      </p:pic>
    </p:spTree>
    <p:extLst>
      <p:ext uri="{BB962C8B-B14F-4D97-AF65-F5344CB8AC3E}">
        <p14:creationId xmlns:p14="http://schemas.microsoft.com/office/powerpoint/2010/main" val="255919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5A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248150"/>
            <a:ext cx="8229600" cy="3230062"/>
          </a:xfrm>
        </p:spPr>
      </p:pic>
    </p:spTree>
    <p:extLst>
      <p:ext uri="{BB962C8B-B14F-4D97-AF65-F5344CB8AC3E}">
        <p14:creationId xmlns:p14="http://schemas.microsoft.com/office/powerpoint/2010/main" val="35006489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5B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7516" y="1600200"/>
            <a:ext cx="7228968" cy="4525963"/>
          </a:xfrm>
        </p:spPr>
      </p:pic>
    </p:spTree>
    <p:extLst>
      <p:ext uri="{BB962C8B-B14F-4D97-AF65-F5344CB8AC3E}">
        <p14:creationId xmlns:p14="http://schemas.microsoft.com/office/powerpoint/2010/main" val="33289090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5D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2374" y="1600200"/>
            <a:ext cx="5099251" cy="4525963"/>
          </a:xfrm>
        </p:spPr>
      </p:pic>
    </p:spTree>
    <p:extLst>
      <p:ext uri="{BB962C8B-B14F-4D97-AF65-F5344CB8AC3E}">
        <p14:creationId xmlns:p14="http://schemas.microsoft.com/office/powerpoint/2010/main" val="12398092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6A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0761" y="1600200"/>
            <a:ext cx="3062477" cy="4525963"/>
          </a:xfrm>
        </p:spPr>
      </p:pic>
    </p:spTree>
    <p:extLst>
      <p:ext uri="{BB962C8B-B14F-4D97-AF65-F5344CB8AC3E}">
        <p14:creationId xmlns:p14="http://schemas.microsoft.com/office/powerpoint/2010/main" val="4415271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6B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524873"/>
            <a:ext cx="8229600" cy="2676617"/>
          </a:xfrm>
        </p:spPr>
      </p:pic>
    </p:spTree>
    <p:extLst>
      <p:ext uri="{BB962C8B-B14F-4D97-AF65-F5344CB8AC3E}">
        <p14:creationId xmlns:p14="http://schemas.microsoft.com/office/powerpoint/2010/main" val="3030406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FIG. 6C</a:t>
            </a:r>
            <a:endParaRPr lang="zh-CN" altLang="en-US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1230" y="1600200"/>
            <a:ext cx="7241540" cy="4525963"/>
          </a:xfrm>
        </p:spPr>
      </p:pic>
    </p:spTree>
    <p:extLst>
      <p:ext uri="{BB962C8B-B14F-4D97-AF65-F5344CB8AC3E}">
        <p14:creationId xmlns:p14="http://schemas.microsoft.com/office/powerpoint/2010/main" val="714690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9</Words>
  <Application>Microsoft Office PowerPoint</Application>
  <PresentationFormat>全屏显示(4:3)</PresentationFormat>
  <Paragraphs>13</Paragraphs>
  <Slides>1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14" baseType="lpstr">
      <vt:lpstr>Office 主题​​</vt:lpstr>
      <vt:lpstr>FIG. 1B</vt:lpstr>
      <vt:lpstr>FIG. 4B</vt:lpstr>
      <vt:lpstr>FIG. 4D</vt:lpstr>
      <vt:lpstr>FIG. 5A</vt:lpstr>
      <vt:lpstr>FIG. 5B</vt:lpstr>
      <vt:lpstr>FIG. 5D</vt:lpstr>
      <vt:lpstr>FIG. 6A</vt:lpstr>
      <vt:lpstr>FIG. 6B</vt:lpstr>
      <vt:lpstr>FIG. 6C</vt:lpstr>
      <vt:lpstr>FIG. 6D</vt:lpstr>
      <vt:lpstr>FIG. 6E</vt:lpstr>
      <vt:lpstr>FIG. 6I</vt:lpstr>
      <vt:lpstr>FIG. 6J</vt:lpstr>
    </vt:vector>
  </TitlesOfParts>
  <Company>chi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. 1B</dc:title>
  <dc:creator>AutoBVT</dc:creator>
  <cp:lastModifiedBy>AutoBVT</cp:lastModifiedBy>
  <cp:revision>1</cp:revision>
  <dcterms:created xsi:type="dcterms:W3CDTF">2020-06-05T08:45:34Z</dcterms:created>
  <dcterms:modified xsi:type="dcterms:W3CDTF">2020-06-05T08:54:56Z</dcterms:modified>
</cp:coreProperties>
</file>